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2310" y="-1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1929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363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545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631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543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2264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199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3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459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6125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260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87542-4D63-45CA-97C3-1005B0A7B618}" type="datetimeFigureOut">
              <a:rPr lang="en-GB" smtClean="0"/>
              <a:t>05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6CB70-BEEB-4991-A964-DABE111D24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223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30268" y="1124782"/>
            <a:ext cx="2898202" cy="3109325"/>
            <a:chOff x="2031333" y="310547"/>
            <a:chExt cx="2898202" cy="3109325"/>
          </a:xfrm>
        </p:grpSpPr>
        <p:sp>
          <p:nvSpPr>
            <p:cNvPr id="7" name="TextBox 6"/>
            <p:cNvSpPr txBox="1"/>
            <p:nvPr/>
          </p:nvSpPr>
          <p:spPr>
            <a:xfrm>
              <a:off x="2031333" y="310547"/>
              <a:ext cx="8655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brary CA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2031333" y="611560"/>
              <a:ext cx="2898202" cy="2808312"/>
              <a:chOff x="1988840" y="4211960"/>
              <a:chExt cx="2898202" cy="2808312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01" t="10049" b="8681"/>
              <a:stretch/>
            </p:blipFill>
            <p:spPr>
              <a:xfrm>
                <a:off x="2171236" y="4463657"/>
                <a:ext cx="2715806" cy="2340591"/>
              </a:xfrm>
              <a:prstGeom prst="rect">
                <a:avLst/>
              </a:prstGeom>
            </p:spPr>
          </p:pic>
          <p:grpSp>
            <p:nvGrpSpPr>
              <p:cNvPr id="3" name="Group 2"/>
              <p:cNvGrpSpPr/>
              <p:nvPr/>
            </p:nvGrpSpPr>
            <p:grpSpPr>
              <a:xfrm>
                <a:off x="1988840" y="4211960"/>
                <a:ext cx="2033171" cy="2808312"/>
                <a:chOff x="1988840" y="3765970"/>
                <a:chExt cx="2033171" cy="2808312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>
                  <a:off x="3140968" y="3765970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6200000">
                  <a:off x="1850794" y="5070086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3157915" y="6389616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6" name="Group 5"/>
          <p:cNvGrpSpPr/>
          <p:nvPr/>
        </p:nvGrpSpPr>
        <p:grpSpPr>
          <a:xfrm>
            <a:off x="3647304" y="1124782"/>
            <a:ext cx="2905061" cy="3109325"/>
            <a:chOff x="3278125" y="572157"/>
            <a:chExt cx="2905061" cy="3109325"/>
          </a:xfrm>
        </p:grpSpPr>
        <p:grpSp>
          <p:nvGrpSpPr>
            <p:cNvPr id="20" name="Group 19"/>
            <p:cNvGrpSpPr/>
            <p:nvPr/>
          </p:nvGrpSpPr>
          <p:grpSpPr>
            <a:xfrm>
              <a:off x="3284984" y="834547"/>
              <a:ext cx="2898202" cy="2846935"/>
              <a:chOff x="1947896" y="4605385"/>
              <a:chExt cx="2898202" cy="2846935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87" t="8700" b="7291"/>
              <a:stretch/>
            </p:blipFill>
            <p:spPr>
              <a:xfrm>
                <a:off x="2106832" y="4834254"/>
                <a:ext cx="2739266" cy="2419458"/>
              </a:xfrm>
              <a:prstGeom prst="rect">
                <a:avLst/>
              </a:prstGeom>
            </p:spPr>
          </p:pic>
          <p:grpSp>
            <p:nvGrpSpPr>
              <p:cNvPr id="22" name="Group 21"/>
              <p:cNvGrpSpPr/>
              <p:nvPr/>
            </p:nvGrpSpPr>
            <p:grpSpPr>
              <a:xfrm>
                <a:off x="1947896" y="4605385"/>
                <a:ext cx="2033171" cy="2846935"/>
                <a:chOff x="1988840" y="3853947"/>
                <a:chExt cx="2033171" cy="2846935"/>
              </a:xfrm>
            </p:grpSpPr>
            <p:sp>
              <p:nvSpPr>
                <p:cNvPr id="23" name="TextBox 22"/>
                <p:cNvSpPr txBox="1"/>
                <p:nvPr/>
              </p:nvSpPr>
              <p:spPr>
                <a:xfrm>
                  <a:off x="3217487" y="3853947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 rot="16200000">
                  <a:off x="1850794" y="5196686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157915" y="6516216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6" name="TextBox 25"/>
            <p:cNvSpPr txBox="1"/>
            <p:nvPr/>
          </p:nvSpPr>
          <p:spPr>
            <a:xfrm>
              <a:off x="3278125" y="572157"/>
              <a:ext cx="8655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brary TC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230268" y="4719714"/>
            <a:ext cx="2898202" cy="3233210"/>
            <a:chOff x="472151" y="5128664"/>
            <a:chExt cx="2898202" cy="3233210"/>
          </a:xfrm>
        </p:grpSpPr>
        <p:grpSp>
          <p:nvGrpSpPr>
            <p:cNvPr id="27" name="Group 26"/>
            <p:cNvGrpSpPr/>
            <p:nvPr/>
          </p:nvGrpSpPr>
          <p:grpSpPr>
            <a:xfrm>
              <a:off x="472151" y="5508827"/>
              <a:ext cx="2898202" cy="2853047"/>
              <a:chOff x="1940816" y="4383249"/>
              <a:chExt cx="2898202" cy="2853047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44" t="10337" b="6925"/>
              <a:stretch/>
            </p:blipFill>
            <p:spPr>
              <a:xfrm>
                <a:off x="2101410" y="4641173"/>
                <a:ext cx="2737608" cy="2382867"/>
              </a:xfrm>
              <a:prstGeom prst="rect">
                <a:avLst/>
              </a:prstGeom>
            </p:spPr>
          </p:pic>
          <p:grpSp>
            <p:nvGrpSpPr>
              <p:cNvPr id="29" name="Group 28"/>
              <p:cNvGrpSpPr/>
              <p:nvPr/>
            </p:nvGrpSpPr>
            <p:grpSpPr>
              <a:xfrm>
                <a:off x="1940816" y="4383249"/>
                <a:ext cx="2033171" cy="2853047"/>
                <a:chOff x="1988840" y="3709931"/>
                <a:chExt cx="2033171" cy="2853047"/>
              </a:xfrm>
            </p:grpSpPr>
            <p:sp>
              <p:nvSpPr>
                <p:cNvPr id="30" name="TextBox 29"/>
                <p:cNvSpPr txBox="1"/>
                <p:nvPr/>
              </p:nvSpPr>
              <p:spPr>
                <a:xfrm>
                  <a:off x="3217487" y="3709931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 rot="16200000">
                  <a:off x="1850794" y="5058782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3157915" y="6378312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9" name="TextBox 38"/>
            <p:cNvSpPr txBox="1"/>
            <p:nvPr/>
          </p:nvSpPr>
          <p:spPr>
            <a:xfrm>
              <a:off x="481488" y="5128664"/>
              <a:ext cx="8655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brary AG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619721" y="4719714"/>
            <a:ext cx="2932644" cy="3140877"/>
            <a:chOff x="3626580" y="5128664"/>
            <a:chExt cx="2932644" cy="3140877"/>
          </a:xfrm>
        </p:grpSpPr>
        <p:grpSp>
          <p:nvGrpSpPr>
            <p:cNvPr id="48" name="Group 47"/>
            <p:cNvGrpSpPr/>
            <p:nvPr/>
          </p:nvGrpSpPr>
          <p:grpSpPr>
            <a:xfrm>
              <a:off x="3626580" y="5450379"/>
              <a:ext cx="2932644" cy="2819162"/>
              <a:chOff x="3626580" y="5450379"/>
              <a:chExt cx="2932644" cy="2819162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44" t="8134" b="7338"/>
              <a:stretch/>
            </p:blipFill>
            <p:spPr>
              <a:xfrm>
                <a:off x="3821616" y="5650434"/>
                <a:ext cx="2737608" cy="2434441"/>
              </a:xfrm>
              <a:prstGeom prst="rect">
                <a:avLst/>
              </a:prstGeom>
            </p:spPr>
          </p:pic>
          <p:grpSp>
            <p:nvGrpSpPr>
              <p:cNvPr id="42" name="Group 41"/>
              <p:cNvGrpSpPr/>
              <p:nvPr/>
            </p:nvGrpSpPr>
            <p:grpSpPr>
              <a:xfrm>
                <a:off x="3626580" y="5450379"/>
                <a:ext cx="2047260" cy="2819162"/>
                <a:chOff x="1769820" y="3851920"/>
                <a:chExt cx="2047260" cy="2819162"/>
              </a:xfrm>
            </p:grpSpPr>
            <p:sp>
              <p:nvSpPr>
                <p:cNvPr id="43" name="TextBox 42"/>
                <p:cNvSpPr txBox="1"/>
                <p:nvPr/>
              </p:nvSpPr>
              <p:spPr>
                <a:xfrm>
                  <a:off x="3029503" y="3851920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 rot="16200000">
                  <a:off x="1631774" y="5176862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2901612" y="6486416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6" name="TextBox 45"/>
            <p:cNvSpPr txBox="1"/>
            <p:nvPr/>
          </p:nvSpPr>
          <p:spPr>
            <a:xfrm>
              <a:off x="3670729" y="5128664"/>
              <a:ext cx="8655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brary AC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575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88640" y="927611"/>
            <a:ext cx="2946026" cy="3171387"/>
            <a:chOff x="387635" y="548687"/>
            <a:chExt cx="2946026" cy="3171387"/>
          </a:xfrm>
        </p:grpSpPr>
        <p:grpSp>
          <p:nvGrpSpPr>
            <p:cNvPr id="15" name="Group 14"/>
            <p:cNvGrpSpPr/>
            <p:nvPr/>
          </p:nvGrpSpPr>
          <p:grpSpPr>
            <a:xfrm>
              <a:off x="387635" y="827584"/>
              <a:ext cx="2946026" cy="2892490"/>
              <a:chOff x="1768315" y="4343806"/>
              <a:chExt cx="2946026" cy="289249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19" t="9345" b="6951"/>
              <a:stretch/>
            </p:blipFill>
            <p:spPr>
              <a:xfrm>
                <a:off x="1952981" y="4631838"/>
                <a:ext cx="2761360" cy="2410692"/>
              </a:xfrm>
              <a:prstGeom prst="rect">
                <a:avLst/>
              </a:prstGeom>
            </p:spPr>
          </p:pic>
          <p:grpSp>
            <p:nvGrpSpPr>
              <p:cNvPr id="6" name="Group 5"/>
              <p:cNvGrpSpPr/>
              <p:nvPr/>
            </p:nvGrpSpPr>
            <p:grpSpPr>
              <a:xfrm>
                <a:off x="1768315" y="4343806"/>
                <a:ext cx="2160051" cy="2892490"/>
                <a:chOff x="1744565" y="3780670"/>
                <a:chExt cx="2160051" cy="2892490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3117039" y="3780670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6200000">
                  <a:off x="1606519" y="5181715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877863" y="6488494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6" name="TextBox 15"/>
            <p:cNvSpPr txBox="1"/>
            <p:nvPr/>
          </p:nvSpPr>
          <p:spPr>
            <a:xfrm>
              <a:off x="387635" y="548687"/>
              <a:ext cx="8655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brary CT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447042" y="925985"/>
            <a:ext cx="2973925" cy="3115502"/>
            <a:chOff x="3447042" y="925985"/>
            <a:chExt cx="2973925" cy="3115502"/>
          </a:xfrm>
        </p:grpSpPr>
        <p:grpSp>
          <p:nvGrpSpPr>
            <p:cNvPr id="18" name="Group 17"/>
            <p:cNvGrpSpPr/>
            <p:nvPr/>
          </p:nvGrpSpPr>
          <p:grpSpPr>
            <a:xfrm>
              <a:off x="3447042" y="1189221"/>
              <a:ext cx="2973925" cy="2852266"/>
              <a:chOff x="1763634" y="4219379"/>
              <a:chExt cx="2973925" cy="2852266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44" t="8363" b="6012"/>
              <a:stretch/>
            </p:blipFill>
            <p:spPr>
              <a:xfrm>
                <a:off x="1999949" y="4420988"/>
                <a:ext cx="2737610" cy="2465991"/>
              </a:xfrm>
              <a:prstGeom prst="rect">
                <a:avLst/>
              </a:prstGeom>
            </p:spPr>
          </p:pic>
          <p:grpSp>
            <p:nvGrpSpPr>
              <p:cNvPr id="20" name="Group 19"/>
              <p:cNvGrpSpPr/>
              <p:nvPr/>
            </p:nvGrpSpPr>
            <p:grpSpPr>
              <a:xfrm>
                <a:off x="1763634" y="4219379"/>
                <a:ext cx="2017513" cy="2852266"/>
                <a:chOff x="1886617" y="3635896"/>
                <a:chExt cx="2017513" cy="2852266"/>
              </a:xfrm>
            </p:grpSpPr>
            <p:sp>
              <p:nvSpPr>
                <p:cNvPr id="21" name="TextBox 20"/>
                <p:cNvSpPr txBox="1"/>
                <p:nvPr/>
              </p:nvSpPr>
              <p:spPr>
                <a:xfrm>
                  <a:off x="3116553" y="3635896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 rot="16200000">
                  <a:off x="1748571" y="4854062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991244" y="6303496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4" name="TextBox 23"/>
            <p:cNvSpPr txBox="1"/>
            <p:nvPr/>
          </p:nvSpPr>
          <p:spPr>
            <a:xfrm>
              <a:off x="3471642" y="925985"/>
              <a:ext cx="8655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brary GA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1943003" y="4603451"/>
            <a:ext cx="2948666" cy="3192307"/>
            <a:chOff x="1972709" y="4427984"/>
            <a:chExt cx="2948666" cy="3192307"/>
          </a:xfrm>
        </p:grpSpPr>
        <p:grpSp>
          <p:nvGrpSpPr>
            <p:cNvPr id="26" name="Group 25"/>
            <p:cNvGrpSpPr/>
            <p:nvPr/>
          </p:nvGrpSpPr>
          <p:grpSpPr>
            <a:xfrm>
              <a:off x="1972709" y="4765969"/>
              <a:ext cx="2948666" cy="2854322"/>
              <a:chOff x="1785119" y="4322827"/>
              <a:chExt cx="2948666" cy="2854322"/>
            </a:xfrm>
          </p:grpSpPr>
          <p:pic>
            <p:nvPicPr>
              <p:cNvPr id="27" name="Picture 26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27" t="7625" b="7433"/>
              <a:stretch/>
            </p:blipFill>
            <p:spPr>
              <a:xfrm>
                <a:off x="1969785" y="4533305"/>
                <a:ext cx="2764000" cy="2446317"/>
              </a:xfrm>
              <a:prstGeom prst="rect">
                <a:avLst/>
              </a:prstGeom>
            </p:spPr>
          </p:pic>
          <p:grpSp>
            <p:nvGrpSpPr>
              <p:cNvPr id="28" name="Group 27"/>
              <p:cNvGrpSpPr/>
              <p:nvPr/>
            </p:nvGrpSpPr>
            <p:grpSpPr>
              <a:xfrm>
                <a:off x="1785119" y="4322827"/>
                <a:ext cx="2136811" cy="2854322"/>
                <a:chOff x="1872523" y="3672752"/>
                <a:chExt cx="2136811" cy="2854322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3151351" y="3672752"/>
                  <a:ext cx="7875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mma fits </a:t>
                  </a:r>
                  <a:endParaRPr lang="en-GB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 rot="16200000">
                  <a:off x="1734477" y="5014055"/>
                  <a:ext cx="4607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sity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145238" y="6342408"/>
                  <a:ext cx="8640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GB" sz="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ertion index</a:t>
                  </a:r>
                  <a:endParaRPr lang="en-GB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2" name="TextBox 31"/>
            <p:cNvSpPr txBox="1"/>
            <p:nvPr/>
          </p:nvSpPr>
          <p:spPr>
            <a:xfrm>
              <a:off x="1990438" y="4427984"/>
              <a:ext cx="11864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ster Library</a:t>
              </a:r>
              <a:endParaRPr lang="en-GB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17443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</TotalTime>
  <Words>49</Words>
  <Application>Microsoft Office PowerPoint</Application>
  <PresentationFormat>On-screen Show (4:3)</PresentationFormat>
  <Paragraphs>2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Animal Health Tru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CHARBONNEAU</dc:creator>
  <cp:lastModifiedBy>AMY CHARBONNEAU</cp:lastModifiedBy>
  <cp:revision>16</cp:revision>
  <cp:lastPrinted>2017-03-14T14:29:52Z</cp:lastPrinted>
  <dcterms:created xsi:type="dcterms:W3CDTF">2017-03-14T12:43:23Z</dcterms:created>
  <dcterms:modified xsi:type="dcterms:W3CDTF">2017-05-05T15:59:50Z</dcterms:modified>
</cp:coreProperties>
</file>